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 snapToObjects="1">
      <p:cViewPr varScale="1">
        <p:scale>
          <a:sx n="104" d="100"/>
          <a:sy n="104" d="100"/>
        </p:scale>
        <p:origin x="232" y="7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E726F1-DBA6-DE48-81B0-C36FEBE34E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53F8862-7D10-C442-A8B7-B4D72A5965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4BDFCD-180B-A747-BD43-499E340A0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A4A08F-9DEA-4942-B16A-02CE6815FD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937A31-4324-0043-9ECD-9BF835516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9567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D36F65-09D5-0E4E-B2DB-194DD50F44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DA2E56-0B20-E34E-B474-D369E199C3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7F4A1E-D07F-EB42-9330-EAC010644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BA3734-0FD7-3243-A9E4-A47694137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AF1D55-9580-0741-8D7B-616D73CD2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821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688BD91-2419-4842-9F69-9824D2CD1E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773587-93AE-934D-8071-E2D6830C11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EC958A-4408-6042-9665-200B22A138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16D232-0B2F-BA4B-A24D-69A7BD4F61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08D797-1A9F-294E-AB34-33EA397942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631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10C688-33C5-8841-B71B-6A34E2A566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0DCA4F-2435-EB4B-BFC0-003F834E62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60CAE0-6FC5-7642-99A2-BC890C45B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7141F7-646A-4147-A9EB-689E82C5D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4F092F-DC4D-334E-87A7-7A546DE3DD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114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3886AF-F1FE-DD48-81AE-8166333ED1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32BFEF-8598-664F-BA7C-06C7D32935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AE2D8B-8B44-6D47-AC4D-B7FEB6504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FF6380-1B24-5C49-ADD7-43FC5B028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DDB59D-95CB-B44F-97D8-9F507D4D7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923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A6A27E-A0E5-124F-B72A-7A814F7A97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D08DA9-CE85-CA4A-89A9-B80B52B6653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657780-1FCE-6844-9269-EDB6CF493C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D14315-E735-7E49-835C-731B17EA5B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19DEDF-B889-EC45-9BAC-78D05CC1F4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93EF7B-33EC-F843-9C4E-4EA891CF4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107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C16F28-F7CE-8446-9CED-6ED2AF6CA7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204B66-A3D9-9348-ACDA-20AA720E21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6DBAA0-E148-3E4C-8D82-4FA880D513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15F3016-7AB3-B747-9C98-42880A79DCE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CF76F45-62CF-5846-91CD-DEC65AD4CB2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8181649-5A61-094B-B5E4-7A3B5F868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A24E93A-6E18-FE48-91FC-111529EA35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DEDB7B8-B3A0-424C-B93B-CCACA1926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427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9165B3-84DD-4946-9198-473E88FD8A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4F0E468-08E4-224A-AC9B-B201462BE6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D9B313C-41EB-134A-87F9-B6365D105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DE5D016-D80A-2144-A5E5-9FC54F0160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606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F89D2FB-A4B8-734A-9A1C-35383F00DB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7377CCD-14E3-4449-8402-B3ECC4E09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E735B0B-A01C-0C4F-8A74-675B043F5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889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FE7668-8B02-2D4F-85CF-825AB6C144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98ECCF-2AE1-614B-800E-E32AE3D68B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B93AF5-FF99-E24B-9C69-F807D188D2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EA9FBD-3EE9-ED42-ABAC-A7DFF1ACC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938B7A-5E4F-B549-A168-A91764D258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3D69C9-507E-FD47-B65F-F32CEEDA8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6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A7F5AC-9DDD-E542-9766-E21CA435AD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979DA0C-F324-8F4D-85C4-E3C5A892D2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57DBE5-3B6A-594A-93F7-9C99254A7F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02F67E-5C5A-064F-B51E-662EDA88D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5CB4B0-1CD3-F946-BAB3-7325BFD8A4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3F2779-5AA1-664B-9677-6A71BCCC2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718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EEBC6F4-8E1C-8848-81CB-C2AFCC434E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5D3946-B705-BC45-95B2-741DFCA225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EA1A13-637B-FF4E-BFA2-07DC25FF79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8CD562-DA7F-ED43-B90A-E22E4F09A4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FA6D1F-71B2-CB41-8991-9CA9191CB7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356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6027" y="66992"/>
            <a:ext cx="11779135" cy="370074"/>
          </a:xfrm>
        </p:spPr>
        <p:txBody>
          <a:bodyPr>
            <a:noAutofit/>
          </a:bodyPr>
          <a:lstStyle/>
          <a:p>
            <a:r>
              <a:rPr lang="en-GB" sz="1800" b="1">
                <a:latin typeface="Times" pitchFamily="2" charset="0"/>
              </a:rPr>
              <a:t>Additional </a:t>
            </a:r>
            <a:r>
              <a:rPr lang="en-GB" sz="1800" b="1" dirty="0">
                <a:latin typeface="Times" pitchFamily="2" charset="0"/>
              </a:rPr>
              <a:t>figure 1: Phase light microscopy of THP-1 cells. </a:t>
            </a:r>
            <a:endParaRPr lang="en-US" sz="1800" b="1" dirty="0">
              <a:latin typeface="Times" pitchFamily="2" charset="0"/>
            </a:endParaRP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4273" y="3557106"/>
            <a:ext cx="3730772" cy="2984617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190" y="3646218"/>
            <a:ext cx="3710273" cy="289550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4273" y="415420"/>
            <a:ext cx="3730772" cy="302670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4390" y="533684"/>
            <a:ext cx="3730772" cy="296113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027" y="415572"/>
            <a:ext cx="3730772" cy="3026549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48346" y="3211782"/>
            <a:ext cx="952485" cy="276999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b="1" dirty="0"/>
              <a:t>Control</a:t>
            </a:r>
            <a:endParaRPr lang="en-US" sz="12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4104273" y="3176211"/>
            <a:ext cx="937281" cy="276999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b="1" dirty="0"/>
              <a:t>1000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µ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GB" sz="1200" b="1" dirty="0"/>
              <a:t>/ml</a:t>
            </a:r>
            <a:endParaRPr lang="en-US" sz="12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8174390" y="3176212"/>
            <a:ext cx="880369" cy="276999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txBody>
          <a:bodyPr wrap="none" rtlCol="0">
            <a:spAutoFit/>
          </a:bodyPr>
          <a:lstStyle/>
          <a:p>
            <a:r>
              <a:rPr lang="en-GB" sz="1200" b="1" dirty="0"/>
              <a:t>200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µ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GB" sz="1200" b="1" dirty="0"/>
              <a:t>/ml</a:t>
            </a:r>
            <a:endParaRPr lang="en-US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126027" y="6264724"/>
            <a:ext cx="788677" cy="369332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txBody>
          <a:bodyPr wrap="none" rtlCol="0">
            <a:spAutoFit/>
          </a:bodyPr>
          <a:lstStyle/>
          <a:p>
            <a:r>
              <a:rPr lang="en-GB" sz="1200" b="1" dirty="0"/>
              <a:t>50</a:t>
            </a:r>
            <a:r>
              <a:rPr lang="en-GB" b="1" dirty="0">
                <a:solidFill>
                  <a:srgbClr val="FF0000"/>
                </a:solidFill>
                <a:latin typeface="Calibri" panose="020F0502020204030204"/>
              </a:rPr>
              <a:t>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µ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GB" sz="1200" b="1" dirty="0"/>
              <a:t>/ml</a:t>
            </a:r>
            <a:endParaRPr lang="en-US" sz="12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4104273" y="6264039"/>
            <a:ext cx="801823" cy="276999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txBody>
          <a:bodyPr wrap="none" rtlCol="0">
            <a:spAutoFit/>
          </a:bodyPr>
          <a:lstStyle/>
          <a:p>
            <a:r>
              <a:rPr lang="en-GB" sz="1200" b="1" dirty="0"/>
              <a:t>10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µ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1" dirty="0"/>
              <a:t>/ml</a:t>
            </a:r>
            <a:endParaRPr lang="en-US" sz="1200" b="1" dirty="0"/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96510" y="3557106"/>
            <a:ext cx="3708652" cy="2963407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8198779" y="6206899"/>
            <a:ext cx="1285929" cy="276999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txBody>
          <a:bodyPr wrap="none" rtlCol="0">
            <a:spAutoFit/>
          </a:bodyPr>
          <a:lstStyle/>
          <a:p>
            <a:r>
              <a:rPr lang="en-GB" sz="1200" b="1" dirty="0"/>
              <a:t>PMA(200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µ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 </a:t>
            </a:r>
            <a:r>
              <a:rPr lang="en-GB" sz="1200" b="1" dirty="0"/>
              <a:t>/ml)</a:t>
            </a:r>
            <a:endParaRPr lang="en-US" sz="1200" b="1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3607D0D-EF91-134A-B181-195D3D010A98}"/>
              </a:ext>
            </a:extLst>
          </p:cNvPr>
          <p:cNvSpPr/>
          <p:nvPr/>
        </p:nvSpPr>
        <p:spPr>
          <a:xfrm>
            <a:off x="0" y="6542701"/>
            <a:ext cx="11905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Times" pitchFamily="2" charset="0"/>
              </a:rPr>
              <a:t>Legend; individual panels are of control cells or various concentration of arecoline studied at 48 hours</a:t>
            </a:r>
            <a:endParaRPr lang="en-US" sz="1200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9993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2</Words>
  <Application>Microsoft Macintosh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Additional figure 1: Phase light microscopy of THP-1 cells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ditional figure 1: Phase light microscopy of THP-1 cells. </dc:title>
  <dc:creator>GA Hitman</dc:creator>
  <cp:lastModifiedBy>GA Hitman</cp:lastModifiedBy>
  <cp:revision>1</cp:revision>
  <dcterms:created xsi:type="dcterms:W3CDTF">2021-05-18T15:58:33Z</dcterms:created>
  <dcterms:modified xsi:type="dcterms:W3CDTF">2021-05-18T15:59:34Z</dcterms:modified>
</cp:coreProperties>
</file>